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2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0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5398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603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47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170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723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560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659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6564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693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19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352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487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DE2F52A-78B1-4FBD-804B-A30ECC88351D}"/>
              </a:ext>
            </a:extLst>
          </p:cNvPr>
          <p:cNvSpPr txBox="1"/>
          <p:nvPr/>
        </p:nvSpPr>
        <p:spPr>
          <a:xfrm>
            <a:off x="623147" y="70104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B218545-CE9E-4FFA-9450-9240C9AA3A16}"/>
              </a:ext>
            </a:extLst>
          </p:cNvPr>
          <p:cNvGrpSpPr/>
          <p:nvPr/>
        </p:nvGrpSpPr>
        <p:grpSpPr>
          <a:xfrm>
            <a:off x="638615" y="1563160"/>
            <a:ext cx="5900231" cy="6707614"/>
            <a:chOff x="613901" y="1563160"/>
            <a:chExt cx="5900231" cy="6707614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EA833ED9-821B-45BC-B24E-8326B17F44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63" t="642" r="1111" b="6705"/>
            <a:stretch/>
          </p:blipFill>
          <p:spPr>
            <a:xfrm>
              <a:off x="1049867" y="5145225"/>
              <a:ext cx="4969933" cy="2848550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E940D5E-2B10-4069-8439-CB506ED5ABE5}"/>
                </a:ext>
              </a:extLst>
            </p:cNvPr>
            <p:cNvSpPr txBox="1"/>
            <p:nvPr/>
          </p:nvSpPr>
          <p:spPr>
            <a:xfrm>
              <a:off x="3243781" y="7993775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te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0AA118E-DA72-439D-AE86-824EA773A5FB}"/>
                </a:ext>
              </a:extLst>
            </p:cNvPr>
            <p:cNvSpPr txBox="1"/>
            <p:nvPr/>
          </p:nvSpPr>
          <p:spPr>
            <a:xfrm rot="16200000">
              <a:off x="19187" y="6488081"/>
              <a:ext cx="15872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of patient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B7314F7-03F1-43D5-A1C2-55D42519BBCD}"/>
                </a:ext>
              </a:extLst>
            </p:cNvPr>
            <p:cNvSpPr txBox="1"/>
            <p:nvPr/>
          </p:nvSpPr>
          <p:spPr>
            <a:xfrm rot="16200000">
              <a:off x="4951846" y="6182966"/>
              <a:ext cx="266290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rate (%) / </a:t>
              </a:r>
            </a:p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usyness-adjusted survival index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C38B1878-5B03-4FB7-807D-CFA8A4C4F7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33" t="697" r="833" b="6319"/>
            <a:stretch/>
          </p:blipFill>
          <p:spPr>
            <a:xfrm>
              <a:off x="1003300" y="1930401"/>
              <a:ext cx="5010150" cy="2731522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82C8BC-CFD2-4F10-B61C-5AADE35E7972}"/>
                </a:ext>
              </a:extLst>
            </p:cNvPr>
            <p:cNvSpPr txBox="1"/>
            <p:nvPr/>
          </p:nvSpPr>
          <p:spPr>
            <a:xfrm>
              <a:off x="3243781" y="4624846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te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7F7831D4-F408-4ADB-9E3F-E037ABF113F8}"/>
                </a:ext>
              </a:extLst>
            </p:cNvPr>
            <p:cNvSpPr txBox="1"/>
            <p:nvPr/>
          </p:nvSpPr>
          <p:spPr>
            <a:xfrm rot="16200000">
              <a:off x="19187" y="2998401"/>
              <a:ext cx="15872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of patient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D63C1755-8B91-4F0A-9184-E1AF46528EEF}"/>
                </a:ext>
              </a:extLst>
            </p:cNvPr>
            <p:cNvSpPr txBox="1"/>
            <p:nvPr/>
          </p:nvSpPr>
          <p:spPr>
            <a:xfrm rot="16200000">
              <a:off x="5496705" y="2998401"/>
              <a:ext cx="13885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rate (%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C93C28FC-EA32-4097-8696-45BC7B679284}"/>
                </a:ext>
              </a:extLst>
            </p:cNvPr>
            <p:cNvSpPr txBox="1"/>
            <p:nvPr/>
          </p:nvSpPr>
          <p:spPr>
            <a:xfrm>
              <a:off x="613901" y="156316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D3D3F05A-2CFF-496D-B5F0-91F7B09DD190}"/>
                </a:ext>
              </a:extLst>
            </p:cNvPr>
            <p:cNvSpPr txBox="1"/>
            <p:nvPr/>
          </p:nvSpPr>
          <p:spPr>
            <a:xfrm>
              <a:off x="613901" y="486035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5637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27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ichiro Ohshimo</dc:creator>
  <cp:lastModifiedBy>Shinichiro Ohshimo</cp:lastModifiedBy>
  <cp:revision>70</cp:revision>
  <dcterms:created xsi:type="dcterms:W3CDTF">2022-01-17T15:20:27Z</dcterms:created>
  <dcterms:modified xsi:type="dcterms:W3CDTF">2022-06-17T21:08:04Z</dcterms:modified>
</cp:coreProperties>
</file>